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21B0F0-7C36-43AC-8473-0374FD944580}" v="10" dt="2022-11-22T17:41:44.7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2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rew Fruge" userId="c053735c-1029-4a97-85cf-fa4a071a66d6" providerId="ADAL" clId="{0021B0F0-7C36-43AC-8473-0374FD944580}"/>
    <pc:docChg chg="undo custSel addSld delSld modSld">
      <pc:chgData name="Drew Fruge" userId="c053735c-1029-4a97-85cf-fa4a071a66d6" providerId="ADAL" clId="{0021B0F0-7C36-43AC-8473-0374FD944580}" dt="2022-11-22T17:41:57.126" v="516" actId="20577"/>
      <pc:docMkLst>
        <pc:docMk/>
      </pc:docMkLst>
      <pc:sldChg chg="modSp mod">
        <pc:chgData name="Drew Fruge" userId="c053735c-1029-4a97-85cf-fa4a071a66d6" providerId="ADAL" clId="{0021B0F0-7C36-43AC-8473-0374FD944580}" dt="2022-11-16T16:18:55.744" v="401" actId="20577"/>
        <pc:sldMkLst>
          <pc:docMk/>
          <pc:sldMk cId="3296790968" sldId="256"/>
        </pc:sldMkLst>
        <pc:spChg chg="mod">
          <ac:chgData name="Drew Fruge" userId="c053735c-1029-4a97-85cf-fa4a071a66d6" providerId="ADAL" clId="{0021B0F0-7C36-43AC-8473-0374FD944580}" dt="2022-11-16T16:18:55.744" v="401" actId="20577"/>
          <ac:spMkLst>
            <pc:docMk/>
            <pc:sldMk cId="3296790968" sldId="256"/>
            <ac:spMk id="6" creationId="{E3C38C1E-3B03-4A50-AB4C-C0D61BF3DC16}"/>
          </ac:spMkLst>
        </pc:spChg>
      </pc:sldChg>
      <pc:sldChg chg="modSp mod">
        <pc:chgData name="Drew Fruge" userId="c053735c-1029-4a97-85cf-fa4a071a66d6" providerId="ADAL" clId="{0021B0F0-7C36-43AC-8473-0374FD944580}" dt="2022-11-15T19:43:39.771" v="65" actId="14100"/>
        <pc:sldMkLst>
          <pc:docMk/>
          <pc:sldMk cId="218659571" sldId="257"/>
        </pc:sldMkLst>
        <pc:spChg chg="mod">
          <ac:chgData name="Drew Fruge" userId="c053735c-1029-4a97-85cf-fa4a071a66d6" providerId="ADAL" clId="{0021B0F0-7C36-43AC-8473-0374FD944580}" dt="2022-11-15T19:43:39.771" v="65" actId="14100"/>
          <ac:spMkLst>
            <pc:docMk/>
            <pc:sldMk cId="218659571" sldId="257"/>
            <ac:spMk id="4" creationId="{8D27E59F-3C22-4EC1-A686-6637397A386A}"/>
          </ac:spMkLst>
        </pc:spChg>
      </pc:sldChg>
      <pc:sldChg chg="addSp modSp mod">
        <pc:chgData name="Drew Fruge" userId="c053735c-1029-4a97-85cf-fa4a071a66d6" providerId="ADAL" clId="{0021B0F0-7C36-43AC-8473-0374FD944580}" dt="2022-11-22T17:41:57.126" v="516" actId="20577"/>
        <pc:sldMkLst>
          <pc:docMk/>
          <pc:sldMk cId="3896533696" sldId="258"/>
        </pc:sldMkLst>
        <pc:spChg chg="mod">
          <ac:chgData name="Drew Fruge" userId="c053735c-1029-4a97-85cf-fa4a071a66d6" providerId="ADAL" clId="{0021B0F0-7C36-43AC-8473-0374FD944580}" dt="2022-11-22T17:41:10.606" v="502" actId="404"/>
          <ac:spMkLst>
            <pc:docMk/>
            <pc:sldMk cId="3896533696" sldId="258"/>
            <ac:spMk id="8" creationId="{05A2E463-6DDC-4CAE-A3E1-1686B77CF828}"/>
          </ac:spMkLst>
        </pc:spChg>
        <pc:spChg chg="add mod">
          <ac:chgData name="Drew Fruge" userId="c053735c-1029-4a97-85cf-fa4a071a66d6" providerId="ADAL" clId="{0021B0F0-7C36-43AC-8473-0374FD944580}" dt="2022-11-22T17:41:42.008" v="512" actId="14100"/>
          <ac:spMkLst>
            <pc:docMk/>
            <pc:sldMk cId="3896533696" sldId="258"/>
            <ac:spMk id="9" creationId="{9D654366-D3D5-5B84-3D51-D159182E78A2}"/>
          </ac:spMkLst>
        </pc:spChg>
        <pc:spChg chg="add mod">
          <ac:chgData name="Drew Fruge" userId="c053735c-1029-4a97-85cf-fa4a071a66d6" providerId="ADAL" clId="{0021B0F0-7C36-43AC-8473-0374FD944580}" dt="2022-11-22T17:41:57.126" v="516" actId="20577"/>
          <ac:spMkLst>
            <pc:docMk/>
            <pc:sldMk cId="3896533696" sldId="258"/>
            <ac:spMk id="10" creationId="{BC5E1FE8-D071-5E44-40BF-A7CE6F41EF15}"/>
          </ac:spMkLst>
        </pc:spChg>
        <pc:picChg chg="add mod">
          <ac:chgData name="Drew Fruge" userId="c053735c-1029-4a97-85cf-fa4a071a66d6" providerId="ADAL" clId="{0021B0F0-7C36-43AC-8473-0374FD944580}" dt="2022-11-22T17:39:24.762" v="414" actId="1076"/>
          <ac:picMkLst>
            <pc:docMk/>
            <pc:sldMk cId="3896533696" sldId="258"/>
            <ac:picMk id="2" creationId="{0CCBC5D7-E50A-2208-234D-E1466ABDD261}"/>
          </ac:picMkLst>
        </pc:picChg>
        <pc:picChg chg="mod">
          <ac:chgData name="Drew Fruge" userId="c053735c-1029-4a97-85cf-fa4a071a66d6" providerId="ADAL" clId="{0021B0F0-7C36-43AC-8473-0374FD944580}" dt="2022-11-22T17:37:37.020" v="406" actId="1076"/>
          <ac:picMkLst>
            <pc:docMk/>
            <pc:sldMk cId="3896533696" sldId="258"/>
            <ac:picMk id="3" creationId="{6DA9D055-5137-427E-97AF-9F22EA6BFD2D}"/>
          </ac:picMkLst>
        </pc:picChg>
        <pc:picChg chg="add mod">
          <ac:chgData name="Drew Fruge" userId="c053735c-1029-4a97-85cf-fa4a071a66d6" providerId="ADAL" clId="{0021B0F0-7C36-43AC-8473-0374FD944580}" dt="2022-11-22T17:39:32.604" v="415" actId="1076"/>
          <ac:picMkLst>
            <pc:docMk/>
            <pc:sldMk cId="3896533696" sldId="258"/>
            <ac:picMk id="4" creationId="{5476F79E-81AE-1C83-C581-BC61739A46D1}"/>
          </ac:picMkLst>
        </pc:picChg>
        <pc:picChg chg="mod">
          <ac:chgData name="Drew Fruge" userId="c053735c-1029-4a97-85cf-fa4a071a66d6" providerId="ADAL" clId="{0021B0F0-7C36-43AC-8473-0374FD944580}" dt="2022-11-22T17:37:37.020" v="406" actId="1076"/>
          <ac:picMkLst>
            <pc:docMk/>
            <pc:sldMk cId="3896533696" sldId="258"/>
            <ac:picMk id="5" creationId="{4B5071AB-4FF2-4FDC-9880-A84D34359879}"/>
          </ac:picMkLst>
        </pc:picChg>
        <pc:picChg chg="add mod">
          <ac:chgData name="Drew Fruge" userId="c053735c-1029-4a97-85cf-fa4a071a66d6" providerId="ADAL" clId="{0021B0F0-7C36-43AC-8473-0374FD944580}" dt="2022-11-22T17:39:38.206" v="416" actId="1076"/>
          <ac:picMkLst>
            <pc:docMk/>
            <pc:sldMk cId="3896533696" sldId="258"/>
            <ac:picMk id="6" creationId="{5624D5EF-2BB0-D348-3813-6E50611C65AF}"/>
          </ac:picMkLst>
        </pc:picChg>
        <pc:picChg chg="mod">
          <ac:chgData name="Drew Fruge" userId="c053735c-1029-4a97-85cf-fa4a071a66d6" providerId="ADAL" clId="{0021B0F0-7C36-43AC-8473-0374FD944580}" dt="2022-11-22T17:37:37.020" v="406" actId="1076"/>
          <ac:picMkLst>
            <pc:docMk/>
            <pc:sldMk cId="3896533696" sldId="258"/>
            <ac:picMk id="7" creationId="{E0B3D4B5-BA48-440E-B68E-C2D05A388B9D}"/>
          </ac:picMkLst>
        </pc:picChg>
      </pc:sldChg>
      <pc:sldChg chg="addSp delSp new del mod">
        <pc:chgData name="Drew Fruge" userId="c053735c-1029-4a97-85cf-fa4a071a66d6" providerId="ADAL" clId="{0021B0F0-7C36-43AC-8473-0374FD944580}" dt="2022-11-16T15:59:05.311" v="147" actId="47"/>
        <pc:sldMkLst>
          <pc:docMk/>
          <pc:sldMk cId="3436074185" sldId="259"/>
        </pc:sldMkLst>
        <pc:picChg chg="add del">
          <ac:chgData name="Drew Fruge" userId="c053735c-1029-4a97-85cf-fa4a071a66d6" providerId="ADAL" clId="{0021B0F0-7C36-43AC-8473-0374FD944580}" dt="2022-11-16T15:55:48.342" v="143" actId="478"/>
          <ac:picMkLst>
            <pc:docMk/>
            <pc:sldMk cId="3436074185" sldId="259"/>
            <ac:picMk id="2" creationId="{4792F050-5378-18BD-37DE-33EDA4997BB4}"/>
          </ac:picMkLst>
        </pc:picChg>
        <pc:picChg chg="add">
          <ac:chgData name="Drew Fruge" userId="c053735c-1029-4a97-85cf-fa4a071a66d6" providerId="ADAL" clId="{0021B0F0-7C36-43AC-8473-0374FD944580}" dt="2022-11-16T15:55:51.028" v="144"/>
          <ac:picMkLst>
            <pc:docMk/>
            <pc:sldMk cId="3436074185" sldId="259"/>
            <ac:picMk id="3" creationId="{7B45C1D0-98EB-980D-C64E-FAF3D7A80648}"/>
          </ac:picMkLst>
        </pc:picChg>
      </pc:sldChg>
      <pc:sldChg chg="addSp new del">
        <pc:chgData name="Drew Fruge" userId="c053735c-1029-4a97-85cf-fa4a071a66d6" providerId="ADAL" clId="{0021B0F0-7C36-43AC-8473-0374FD944580}" dt="2022-11-16T16:00:02.098" v="152" actId="47"/>
        <pc:sldMkLst>
          <pc:docMk/>
          <pc:sldMk cId="2838440372" sldId="260"/>
        </pc:sldMkLst>
        <pc:picChg chg="add">
          <ac:chgData name="Drew Fruge" userId="c053735c-1029-4a97-85cf-fa4a071a66d6" providerId="ADAL" clId="{0021B0F0-7C36-43AC-8473-0374FD944580}" dt="2022-11-16T15:58:39.349" v="146"/>
          <ac:picMkLst>
            <pc:docMk/>
            <pc:sldMk cId="2838440372" sldId="260"/>
            <ac:picMk id="2" creationId="{84CC61B5-AC99-84C3-6E38-F3C3B929A950}"/>
          </ac:picMkLst>
        </pc:picChg>
      </pc:sldChg>
      <pc:sldChg chg="addSp modSp new mod">
        <pc:chgData name="Drew Fruge" userId="c053735c-1029-4a97-85cf-fa4a071a66d6" providerId="ADAL" clId="{0021B0F0-7C36-43AC-8473-0374FD944580}" dt="2022-11-16T16:02:20.928" v="400" actId="20577"/>
        <pc:sldMkLst>
          <pc:docMk/>
          <pc:sldMk cId="2708136460" sldId="261"/>
        </pc:sldMkLst>
        <pc:spChg chg="add mod">
          <ac:chgData name="Drew Fruge" userId="c053735c-1029-4a97-85cf-fa4a071a66d6" providerId="ADAL" clId="{0021B0F0-7C36-43AC-8473-0374FD944580}" dt="2022-11-16T16:02:20.928" v="400" actId="20577"/>
          <ac:spMkLst>
            <pc:docMk/>
            <pc:sldMk cId="2708136460" sldId="261"/>
            <ac:spMk id="3" creationId="{3BDCFDF0-5ECC-D707-D75C-5E5B7982A53D}"/>
          </ac:spMkLst>
        </pc:spChg>
        <pc:picChg chg="add mod">
          <ac:chgData name="Drew Fruge" userId="c053735c-1029-4a97-85cf-fa4a071a66d6" providerId="ADAL" clId="{0021B0F0-7C36-43AC-8473-0374FD944580}" dt="2022-11-16T16:00:11.080" v="170" actId="1035"/>
          <ac:picMkLst>
            <pc:docMk/>
            <pc:sldMk cId="2708136460" sldId="261"/>
            <ac:picMk id="2" creationId="{62BA8F56-BC11-B9C6-E0FC-FB41BE9F3A5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2857B-5536-492D-BE3F-557B64CE9B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97634A0-791B-4B83-B236-73B4F1381F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787C6-5AC0-4882-B6FE-D00BD145A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530FC-3D9F-417F-A58E-33E9F0BC0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FD2A09-D426-42D5-ACEC-D2941B8A3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67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EA6306-E521-4BF1-AC5E-F7493BDE2D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9E25A2-04DD-446C-9E1A-0FED2FA10F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777756-B163-4533-A0F9-E56FB9CBD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1A3D4C-0048-4E6F-AF50-A2EFB7C2FC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4905E2-1041-4593-AB86-E140CF224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657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444975-3411-4987-92FE-F8C2D8D8B7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9EACFEC-FAEE-495A-8C79-2C2B997A13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7734C-631B-48C3-8D7A-D194310D43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CDF340-1160-4DA8-8020-C1A011841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B805A7-60D4-4FDB-BAD4-CAF74C939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958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FEB17-74B9-4A68-AAB1-4D62309E0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BBD6BA-C45A-4733-9545-44D82C7030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1E0E8B-DCF5-4372-BB50-4E103A13C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90019D-59E2-4A59-B9D7-EDACD203A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D62157-9156-49EF-9E01-1E7785034B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0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B40246-F562-4710-BF36-036BBC666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9C83BC-9169-4065-8F1E-07F120313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2EFE4A-3CA5-47CC-BAC2-049DAA5CE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B406E9-2952-411F-A8CF-FBC409A3C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2D9DC6-C090-40A8-BAF2-A078197CA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628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511F-2D73-481A-9CC3-504B825C21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E1CB11-6DE7-488B-9D9C-91EB8E3D89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E9B193-6D06-4864-BD9E-33320615E3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A1CCC1-F9C2-438B-BD47-9E21B1B0E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E87C48-CD39-4B5E-87F3-47F68FD42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25748F-6358-41A5-A8E3-64B9180D5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211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975147-ADED-4661-BB4B-E8496AFDAD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F26AFA-97E3-4D13-9529-CC03017A62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2DE95D-0458-48EF-AEBC-A849546FC2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CD8374-D2D4-4519-BB9C-6A57D08B42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C54DBFF-042D-4DAD-8150-A57F4F631A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C0D87D-F58C-4A96-98FC-0B9C829E1D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09C444-701D-4C22-9174-25591482C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06E02A-064D-4815-B1EC-E4C3D7CE56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237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B3E70-3548-4BBD-A419-282BCBC151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37A4F03-1CBC-47CA-8683-941DD6073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F000A0-72D6-4B8E-A52C-C66D49108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F9FFE8-092B-4740-AB0C-A11CD40BD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171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CDB34C-89D2-471D-84F5-ED152D683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9274BD9-D151-4E07-8177-F0C063BAB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C9EB12-2B69-4530-9BE0-2A07E4812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787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A8295-A764-4695-816A-6BD31CA3C7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4C41D0-48E8-40B6-8C2F-A3A553999C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409362-BD45-4AF5-8E60-2FE4CE6146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D670C6-FD53-4E1F-90B9-16D412D1D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A2D0F5-BFFC-496B-93D3-0144ACF10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361136-D0AE-4499-A047-BBC8A0351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500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0D3ECF-23E5-41AD-83EA-FFA32E35D9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A65CD6-7714-40FF-A7D2-46043261FC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24224E-CA18-4F34-8BCC-2F21D224CE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F70632-EC0A-4697-9304-A4F0D9F48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290943-8FE7-441E-A9A1-4EA507066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CB6221-10BA-4036-B132-E076E7128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437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A1ACF87-E7EB-47AB-80C5-35A78F0294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6AF8A2-7EC4-41FD-AAF2-3F8DC6FE05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FA46C3-BFB2-4C55-88C2-2BAA15DFEF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F96CB-9D59-4F58-A34C-B0A61CD6743C}" type="datetimeFigureOut">
              <a:rPr lang="en-US" smtClean="0"/>
              <a:t>1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29F917-5DC1-4EC6-A7E7-C66E23BE04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C41588-2D8D-4E40-B5AE-2BEFE676FB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5E4E7C-9034-4055-9DA3-E74C8AEF6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80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diagram&#10;&#10;Description automatically generated">
            <a:extLst>
              <a:ext uri="{FF2B5EF4-FFF2-40B4-BE49-F238E27FC236}">
                <a16:creationId xmlns:a16="http://schemas.microsoft.com/office/drawing/2014/main" id="{E1E12608-767F-426C-9EF3-B1911BA955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4560" y="10967"/>
            <a:ext cx="8622314" cy="646673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3C38C1E-3B03-4A50-AB4C-C0D61BF3DC16}"/>
              </a:ext>
            </a:extLst>
          </p:cNvPr>
          <p:cNvSpPr txBox="1"/>
          <p:nvPr/>
        </p:nvSpPr>
        <p:spPr>
          <a:xfrm>
            <a:off x="522513" y="6477702"/>
            <a:ext cx="110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1. Rarefaction curve of alpha diversity (PD whole tree phylogeny) by sample. </a:t>
            </a:r>
          </a:p>
        </p:txBody>
      </p:sp>
    </p:spTree>
    <p:extLst>
      <p:ext uri="{BB962C8B-B14F-4D97-AF65-F5344CB8AC3E}">
        <p14:creationId xmlns:p14="http://schemas.microsoft.com/office/powerpoint/2010/main" val="3296790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chart&#10;&#10;Description automatically generated">
            <a:extLst>
              <a:ext uri="{FF2B5EF4-FFF2-40B4-BE49-F238E27FC236}">
                <a16:creationId xmlns:a16="http://schemas.microsoft.com/office/drawing/2014/main" id="{C8534111-1B89-4996-A584-775966BE91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20177"/>
            <a:ext cx="12192000" cy="501764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D27E59F-3C22-4EC1-A686-6637397A386A}"/>
              </a:ext>
            </a:extLst>
          </p:cNvPr>
          <p:cNvSpPr txBox="1"/>
          <p:nvPr/>
        </p:nvSpPr>
        <p:spPr>
          <a:xfrm>
            <a:off x="940525" y="6477702"/>
            <a:ext cx="11077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2. Phred scores of study samples (n=98) indicating &gt;99.9% accuracy </a:t>
            </a:r>
          </a:p>
        </p:txBody>
      </p:sp>
    </p:spTree>
    <p:extLst>
      <p:ext uri="{BB962C8B-B14F-4D97-AF65-F5344CB8AC3E}">
        <p14:creationId xmlns:p14="http://schemas.microsoft.com/office/powerpoint/2010/main" val="2186595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6DA9D055-5137-427E-97AF-9F22EA6BFD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046" y="10966"/>
            <a:ext cx="3264379" cy="3264379"/>
          </a:xfrm>
          <a:prstGeom prst="rect">
            <a:avLst/>
          </a:prstGeom>
        </p:spPr>
      </p:pic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4B5071AB-4FF2-4FDC-9880-A84D3435987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810" y="10966"/>
            <a:ext cx="3264379" cy="3264379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E0B3D4B5-BA48-440E-B68E-C2D05A388B9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0574" y="10966"/>
            <a:ext cx="3264379" cy="326437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5A2E463-6DDC-4CAE-A3E1-1686B77CF828}"/>
              </a:ext>
            </a:extLst>
          </p:cNvPr>
          <p:cNvSpPr txBox="1"/>
          <p:nvPr/>
        </p:nvSpPr>
        <p:spPr>
          <a:xfrm>
            <a:off x="164052" y="6477702"/>
            <a:ext cx="120279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l Figure S3. Dissimilarity plots comparing males (blue squares) and females (red circles). a) Bray Curtis, </a:t>
            </a:r>
            <a:r>
              <a:rPr lang="en-US" sz="1400" i="1" dirty="0"/>
              <a:t>p</a:t>
            </a:r>
            <a:r>
              <a:rPr lang="en-US" sz="1400" dirty="0"/>
              <a:t> = 0.007; b) Unweighted Unifrac, </a:t>
            </a:r>
            <a:r>
              <a:rPr lang="en-US" sz="1400" i="1" dirty="0"/>
              <a:t>p </a:t>
            </a:r>
            <a:r>
              <a:rPr lang="en-US" sz="1400" dirty="0"/>
              <a:t>= 0.005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CCBC5D7-E50A-2208-234D-E1466ABDD26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7046" y="3213323"/>
            <a:ext cx="3264379" cy="326437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476F79E-81AE-1C83-C581-BC61739A46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60370" y="3213323"/>
            <a:ext cx="3264379" cy="326437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624D5EF-2BB0-D348-3813-6E50611C65A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60574" y="3213323"/>
            <a:ext cx="3264379" cy="326437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D654366-D3D5-5B84-3D51-D159182E78A2}"/>
              </a:ext>
            </a:extLst>
          </p:cNvPr>
          <p:cNvSpPr txBox="1"/>
          <p:nvPr/>
        </p:nvSpPr>
        <p:spPr>
          <a:xfrm>
            <a:off x="69098" y="226409"/>
            <a:ext cx="4011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C5E1FE8-D071-5E44-40BF-A7CE6F41EF15}"/>
              </a:ext>
            </a:extLst>
          </p:cNvPr>
          <p:cNvSpPr txBox="1"/>
          <p:nvPr/>
        </p:nvSpPr>
        <p:spPr>
          <a:xfrm>
            <a:off x="69097" y="3401249"/>
            <a:ext cx="4011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8965336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2BA8F56-BC11-B9C6-E0FC-FB41BE9F3A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6356" y="16561"/>
            <a:ext cx="11059287" cy="634227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BDCFDF0-5ECC-D707-D75C-5E5B7982A53D}"/>
              </a:ext>
            </a:extLst>
          </p:cNvPr>
          <p:cNvSpPr txBox="1"/>
          <p:nvPr/>
        </p:nvSpPr>
        <p:spPr>
          <a:xfrm>
            <a:off x="0" y="6477702"/>
            <a:ext cx="12192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Supplemental </a:t>
            </a:r>
            <a:r>
              <a:rPr lang="en-US" sz="1500"/>
              <a:t>Figure S4</a:t>
            </a:r>
            <a:r>
              <a:rPr lang="en-US" sz="1500" dirty="0"/>
              <a:t>. Spearman correlations between POMS subscales and top 25 genera by intervention group. Highlighted cells indicate p&lt;0.05.</a:t>
            </a:r>
          </a:p>
        </p:txBody>
      </p:sp>
    </p:spTree>
    <p:extLst>
      <p:ext uri="{BB962C8B-B14F-4D97-AF65-F5344CB8AC3E}">
        <p14:creationId xmlns:p14="http://schemas.microsoft.com/office/powerpoint/2010/main" val="2708136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2</TotalTime>
  <Words>99</Words>
  <Application>Microsoft Office PowerPoint</Application>
  <PresentationFormat>Widescreen</PresentationFormat>
  <Paragraphs>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ew Fruge</dc:creator>
  <cp:lastModifiedBy>MDPI</cp:lastModifiedBy>
  <cp:revision>2</cp:revision>
  <dcterms:created xsi:type="dcterms:W3CDTF">2022-11-15T19:32:23Z</dcterms:created>
  <dcterms:modified xsi:type="dcterms:W3CDTF">2022-11-26T10:12:04Z</dcterms:modified>
</cp:coreProperties>
</file>